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493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268061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645077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994443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36490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065317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30407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744360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936833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07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317074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43901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59690-0BF9-4F31-9CB4-6BBE746322EE}" type="datetimeFigureOut">
              <a:rPr lang="nl-BE" smtClean="0"/>
              <a:t>12/04/2016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835C3-594D-417D-9308-5FB462C4BE32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88868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kstvak 8"/>
          <p:cNvSpPr txBox="1"/>
          <p:nvPr/>
        </p:nvSpPr>
        <p:spPr>
          <a:xfrm>
            <a:off x="1547664" y="4365104"/>
            <a:ext cx="61926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nl-B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nl-B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lot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>
                <a:latin typeface="Arial" panose="020B0604020202020204" pitchFamily="34" charset="0"/>
                <a:cs typeface="Arial" panose="020B0604020202020204" pitchFamily="34" charset="0"/>
              </a:rPr>
              <a:t>estimated</a:t>
            </a:r>
            <a:r>
              <a:rPr lang="nl-BE" sz="1200" dirty="0">
                <a:latin typeface="Arial" panose="020B0604020202020204" pitchFamily="34" charset="0"/>
                <a:cs typeface="Arial" panose="020B0604020202020204" pitchFamily="34" charset="0"/>
              </a:rPr>
              <a:t> tumor zone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>
                <a:latin typeface="Arial" panose="020B0604020202020204" pitchFamily="34" charset="0"/>
                <a:cs typeface="Arial" panose="020B0604020202020204" pitchFamily="34" charset="0"/>
              </a:rPr>
              <a:t>coverage</a:t>
            </a:r>
            <a:r>
              <a:rPr lang="nl-B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 sample. The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tted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line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et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verag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reshold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300. The percentage of samples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ll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elow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t-off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%) is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umor zone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t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ost are NSCLC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ecimens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The different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ymbols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3 tumor types </a:t>
            </a:r>
            <a:r>
              <a:rPr lang="nl-B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sted</a:t>
            </a:r>
            <a:r>
              <a:rPr lang="nl-B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pen triangles represent CRC, closed diamonds are NSCLC, and grey squares indicate MELA samples. </a:t>
            </a:r>
            <a:endParaRPr lang="nl-B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8468" y="1268760"/>
            <a:ext cx="4771238" cy="28335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" name="Rechte verbindingslijn 2"/>
          <p:cNvCxnSpPr/>
          <p:nvPr/>
        </p:nvCxnSpPr>
        <p:spPr>
          <a:xfrm>
            <a:off x="2583744" y="2685546"/>
            <a:ext cx="3816424" cy="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kstvak 6"/>
          <p:cNvSpPr txBox="1"/>
          <p:nvPr/>
        </p:nvSpPr>
        <p:spPr>
          <a:xfrm>
            <a:off x="6400168" y="256284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1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nl-BE" sz="1100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4798707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</Words>
  <Application>Microsoft Office PowerPoint</Application>
  <PresentationFormat>Diavoorstelling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Kantoorthema</vt:lpstr>
      <vt:lpstr>PowerPoint-presentatie</vt:lpstr>
    </vt:vector>
  </TitlesOfParts>
  <Company>ICT Jess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Guido Froyen</dc:creator>
  <cp:lastModifiedBy>Guido Froyen</cp:lastModifiedBy>
  <cp:revision>1</cp:revision>
  <dcterms:created xsi:type="dcterms:W3CDTF">2016-04-12T06:28:28Z</dcterms:created>
  <dcterms:modified xsi:type="dcterms:W3CDTF">2016-04-12T06:29:06Z</dcterms:modified>
</cp:coreProperties>
</file>